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Props.xml" ContentType="application/vnd.openxmlformats-officedocument.presentationml.presProps+xml"/>
  <Override PartName="/ppt/slideLayouts/slideLayout8.xml" ContentType="application/vnd.openxmlformats-officedocument.presentationml.slideLayout+xml"/>
  <Override PartName="/ppt/presentation.xml" ContentType="application/vnd.openxmlformats-officedocument.presentationml.presentation.main+xml"/>
  <Override PartName="/ppt/slideLayouts/slideLayout4.xml" ContentType="application/vnd.openxmlformats-officedocument.presentationml.slideLayout+xml"/>
  <Override PartName="/docProps/app.xml" ContentType="application/vnd.openxmlformats-officedocument.extended-properties+xml"/>
  <Override PartName="/docProps/core.xml" ContentType="application/vnd.openxmlformats-package.core-properties+xml"/>
  <Override PartName="/ppt/viewProps.xml" ContentType="application/vnd.openxmlformats-officedocument.presentationml.viewProp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000" autoAdjust="0"/>
    <p:restoredTop sz="94660"/>
  </p:normalViewPr>
  <p:slideViewPr>
    <p:cSldViewPr snapToGrid="0">
      <p:cViewPr varScale="1">
        <p:scale>
          <a:sx n="64" d="100"/>
          <a:sy n="64" d="100"/>
        </p:scale>
        <p:origin x="8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0D3BF63-FA62-021C-606C-8ED11AF4D23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F2FB9948-A4C8-8BF9-9139-721509EB4D2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1538EEE4-E7AE-6193-DC00-EC478FEA58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96F601-3F72-4428-B2CF-9450FF0F17F4}" type="datetimeFigureOut">
              <a:rPr lang="pt-BR" smtClean="0"/>
              <a:t>05/02/2026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05A086C7-187A-E1C1-3030-9690E8376F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C9B70D96-AAD7-29D6-9AB7-B64C60BA2C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3070F-48CB-4255-8156-95B8158F64A9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4645081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1A22902-DC33-2296-20E3-C6F5F6403D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D100404E-BD48-EA4D-78E4-0E27B1EA3A8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8C800A14-9C1F-5574-4A73-D591568BFC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96F601-3F72-4428-B2CF-9450FF0F17F4}" type="datetimeFigureOut">
              <a:rPr lang="pt-BR" smtClean="0"/>
              <a:t>05/02/2026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EFE07846-ADC6-8CB2-AFDA-FDC4FB7407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385EAB86-AFA0-3E49-AFA7-5B2D8B5BAF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3070F-48CB-4255-8156-95B8158F64A9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5965292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FBB8EBD6-DA01-BDC2-99E0-2B6325A8AA0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179F185B-9A8B-727D-2B6F-7DA4E79BA5B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CB2AA241-EA88-D0AA-D2AA-1FBB2B150E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96F601-3F72-4428-B2CF-9450FF0F17F4}" type="datetimeFigureOut">
              <a:rPr lang="pt-BR" smtClean="0"/>
              <a:t>05/02/2026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4B92F583-A3B0-920A-4C22-BB8D8610D7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F595CB25-3442-D43F-A35D-9CCA69391E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3070F-48CB-4255-8156-95B8158F64A9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934485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8D576E3-1884-6FFD-8A7F-54FC74894A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6137D5D8-13BB-060E-DA2C-9C9968353C0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7B175326-9BBF-3F15-D30B-B287E754E7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96F601-3F72-4428-B2CF-9450FF0F17F4}" type="datetimeFigureOut">
              <a:rPr lang="pt-BR" smtClean="0"/>
              <a:t>05/02/2026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CE55A817-1B71-CDF9-2C0F-491A3E36C7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FA18484B-B96F-3D58-18AC-59F167425E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3070F-48CB-4255-8156-95B8158F64A9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6561114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953E53C-F9A5-443E-8ADA-95EA83882C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1524797F-8FC5-A888-3715-D55655ACCC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6C117D52-6769-28FA-AE96-50602C1F5F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96F601-3F72-4428-B2CF-9450FF0F17F4}" type="datetimeFigureOut">
              <a:rPr lang="pt-BR" smtClean="0"/>
              <a:t>05/02/2026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6E610DA3-AEB2-C6DA-86EB-24444D0BB7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270B4C7F-C811-3FA1-DCE7-6847588DEF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3070F-48CB-4255-8156-95B8158F64A9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6566741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8A58E6D-41A3-EC47-3C07-DAF875D4E3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291C9ED3-4E22-6159-DCB6-74E176F3FCC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FFF2BBDB-2ED6-1763-F4A5-586E1EA3B13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6775AD3B-1140-1837-9AC4-E4045B0C7A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96F601-3F72-4428-B2CF-9450FF0F17F4}" type="datetimeFigureOut">
              <a:rPr lang="pt-BR" smtClean="0"/>
              <a:t>05/02/2026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BCB93ABA-411A-92C2-0472-E5EC95A4B7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EB196A71-646E-DC9D-A451-28022B311C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3070F-48CB-4255-8156-95B8158F64A9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7274157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D36A8C5-03A2-02E3-85AE-4E2C8F6187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7D43D3DE-C197-5444-0744-DE4C607DC6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D505D6D2-26BF-1FB8-89A6-5630B99BF0A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>
            <a:extLst>
              <a:ext uri="{FF2B5EF4-FFF2-40B4-BE49-F238E27FC236}">
                <a16:creationId xmlns:a16="http://schemas.microsoft.com/office/drawing/2014/main" id="{BD28E1AA-4887-8635-27F2-A90B81B8359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Espaço Reservado para Conteúdo 5">
            <a:extLst>
              <a:ext uri="{FF2B5EF4-FFF2-40B4-BE49-F238E27FC236}">
                <a16:creationId xmlns:a16="http://schemas.microsoft.com/office/drawing/2014/main" id="{365720B0-D7B3-FCAF-99BD-4BB7A289C26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>
            <a:extLst>
              <a:ext uri="{FF2B5EF4-FFF2-40B4-BE49-F238E27FC236}">
                <a16:creationId xmlns:a16="http://schemas.microsoft.com/office/drawing/2014/main" id="{280B7DC2-8CD4-A43F-1898-1ED516FF38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96F601-3F72-4428-B2CF-9450FF0F17F4}" type="datetimeFigureOut">
              <a:rPr lang="pt-BR" smtClean="0"/>
              <a:t>05/02/2026</a:t>
            </a:fld>
            <a:endParaRPr lang="pt-BR"/>
          </a:p>
        </p:txBody>
      </p:sp>
      <p:sp>
        <p:nvSpPr>
          <p:cNvPr id="8" name="Espaço Reservado para Rodapé 7">
            <a:extLst>
              <a:ext uri="{FF2B5EF4-FFF2-40B4-BE49-F238E27FC236}">
                <a16:creationId xmlns:a16="http://schemas.microsoft.com/office/drawing/2014/main" id="{244F6BE2-B8EC-B585-B1C6-49DF6D194F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>
            <a:extLst>
              <a:ext uri="{FF2B5EF4-FFF2-40B4-BE49-F238E27FC236}">
                <a16:creationId xmlns:a16="http://schemas.microsoft.com/office/drawing/2014/main" id="{2B72193D-957E-441F-5919-EB9634776E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3070F-48CB-4255-8156-95B8158F64A9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5486668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83EE744-D5B8-88B2-4F0C-D0DCC83B1A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id="{CB350E21-AE92-0E72-48D5-590F835371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96F601-3F72-4428-B2CF-9450FF0F17F4}" type="datetimeFigureOut">
              <a:rPr lang="pt-BR" smtClean="0"/>
              <a:t>05/02/2026</a:t>
            </a:fld>
            <a:endParaRPr lang="pt-BR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id="{951C23E5-07EC-86B7-D8AC-DA3FB598DF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id="{6D9059F7-6A91-366B-4406-87CA8EE7BB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3070F-48CB-4255-8156-95B8158F64A9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8422047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>
            <a:extLst>
              <a:ext uri="{FF2B5EF4-FFF2-40B4-BE49-F238E27FC236}">
                <a16:creationId xmlns:a16="http://schemas.microsoft.com/office/drawing/2014/main" id="{EC510565-C298-6C94-748C-64B2E776BF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96F601-3F72-4428-B2CF-9450FF0F17F4}" type="datetimeFigureOut">
              <a:rPr lang="pt-BR" smtClean="0"/>
              <a:t>05/02/2026</a:t>
            </a:fld>
            <a:endParaRPr lang="pt-BR"/>
          </a:p>
        </p:txBody>
      </p:sp>
      <p:sp>
        <p:nvSpPr>
          <p:cNvPr id="3" name="Espaço Reservado para Rodapé 2">
            <a:extLst>
              <a:ext uri="{FF2B5EF4-FFF2-40B4-BE49-F238E27FC236}">
                <a16:creationId xmlns:a16="http://schemas.microsoft.com/office/drawing/2014/main" id="{9633DA79-BF97-6CF5-0D42-A963E78CBD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224274D8-88BD-6534-C6BB-88F5B0B607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3070F-48CB-4255-8156-95B8158F64A9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8351051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ECD4645-061F-CF91-E051-8704A81FE7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835D2501-B29F-9AC8-FF58-4A4254C6D4A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E4CF1DE1-0734-646B-DA4B-3141C933CC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D34F3137-5DB8-0FF1-0536-47814FA9DF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96F601-3F72-4428-B2CF-9450FF0F17F4}" type="datetimeFigureOut">
              <a:rPr lang="pt-BR" smtClean="0"/>
              <a:t>05/02/2026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79A3E3F3-90AF-C2C9-240E-815E974F57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6DA686AF-724F-2AA7-DAEB-0EC055E77D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3070F-48CB-4255-8156-95B8158F64A9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3866278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367B228-C2E4-398E-8BAC-6613B781BE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>
            <a:extLst>
              <a:ext uri="{FF2B5EF4-FFF2-40B4-BE49-F238E27FC236}">
                <a16:creationId xmlns:a16="http://schemas.microsoft.com/office/drawing/2014/main" id="{F8C6BB80-DA43-2AA4-CD6F-F3E41558572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89C6FF49-CF7B-C721-350A-361BCF3C413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692107C0-102D-E309-F00E-BA8EAAB015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96F601-3F72-4428-B2CF-9450FF0F17F4}" type="datetimeFigureOut">
              <a:rPr lang="pt-BR" smtClean="0"/>
              <a:t>05/02/2026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A0DBAF4B-9443-304F-99D5-8AC5FFB2DC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3F39D89B-F9B2-074A-7956-050BF6D6E6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B3070F-48CB-4255-8156-95B8158F64A9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658355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>
            <a:extLst>
              <a:ext uri="{FF2B5EF4-FFF2-40B4-BE49-F238E27FC236}">
                <a16:creationId xmlns:a16="http://schemas.microsoft.com/office/drawing/2014/main" id="{BF0E7EC9-6895-F166-3499-9D6786D825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802B8FCD-899E-1B02-2C32-BD0E968C0C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742E39D5-AF54-5D87-C22B-8FD5BD2E29F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496F601-3F72-4428-B2CF-9450FF0F17F4}" type="datetimeFigureOut">
              <a:rPr lang="pt-BR" smtClean="0"/>
              <a:t>05/02/2026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485AFAD7-C9DE-73B8-F646-1E13E6042B3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29B68C9E-CB5A-6E95-2530-50A4F839268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CB3070F-48CB-4255-8156-95B8158F64A9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1969590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ela 6">
            <a:extLst>
              <a:ext uri="{FF2B5EF4-FFF2-40B4-BE49-F238E27FC236}">
                <a16:creationId xmlns:a16="http://schemas.microsoft.com/office/drawing/2014/main" id="{0478C2F8-9453-B8A2-D833-A3EA045238AA}"/>
              </a:ext>
            </a:extLst>
          </p:cNvPr>
          <p:cNvGraphicFramePr>
            <a:graphicFrameLocks noGrp="1"/>
          </p:cNvGraphicFramePr>
          <p:nvPr/>
        </p:nvGraphicFramePr>
        <p:xfrm>
          <a:off x="729673" y="1520611"/>
          <a:ext cx="10252269" cy="3399710"/>
        </p:xfrm>
        <a:graphic>
          <a:graphicData uri="http://schemas.openxmlformats.org/drawingml/2006/table">
            <a:tbl>
              <a:tblPr bandRow="1">
                <a:tableStyleId>{5C22544A-7EE6-4342-B048-85BDC9FD1C3A}</a:tableStyleId>
              </a:tblPr>
              <a:tblGrid>
                <a:gridCol w="1169472">
                  <a:extLst>
                    <a:ext uri="{9D8B030D-6E8A-4147-A177-3AD203B41FA5}">
                      <a16:colId xmlns:a16="http://schemas.microsoft.com/office/drawing/2014/main" val="47675861"/>
                    </a:ext>
                  </a:extLst>
                </a:gridCol>
                <a:gridCol w="1352055">
                  <a:extLst>
                    <a:ext uri="{9D8B030D-6E8A-4147-A177-3AD203B41FA5}">
                      <a16:colId xmlns:a16="http://schemas.microsoft.com/office/drawing/2014/main" val="3866938183"/>
                    </a:ext>
                  </a:extLst>
                </a:gridCol>
                <a:gridCol w="554693">
                  <a:extLst>
                    <a:ext uri="{9D8B030D-6E8A-4147-A177-3AD203B41FA5}">
                      <a16:colId xmlns:a16="http://schemas.microsoft.com/office/drawing/2014/main" val="3341864373"/>
                    </a:ext>
                  </a:extLst>
                </a:gridCol>
                <a:gridCol w="737276">
                  <a:extLst>
                    <a:ext uri="{9D8B030D-6E8A-4147-A177-3AD203B41FA5}">
                      <a16:colId xmlns:a16="http://schemas.microsoft.com/office/drawing/2014/main" val="905689965"/>
                    </a:ext>
                  </a:extLst>
                </a:gridCol>
                <a:gridCol w="737276">
                  <a:extLst>
                    <a:ext uri="{9D8B030D-6E8A-4147-A177-3AD203B41FA5}">
                      <a16:colId xmlns:a16="http://schemas.microsoft.com/office/drawing/2014/main" val="2382711497"/>
                    </a:ext>
                  </a:extLst>
                </a:gridCol>
                <a:gridCol w="851681">
                  <a:extLst>
                    <a:ext uri="{9D8B030D-6E8A-4147-A177-3AD203B41FA5}">
                      <a16:colId xmlns:a16="http://schemas.microsoft.com/office/drawing/2014/main" val="4163879058"/>
                    </a:ext>
                  </a:extLst>
                </a:gridCol>
                <a:gridCol w="1575713">
                  <a:extLst>
                    <a:ext uri="{9D8B030D-6E8A-4147-A177-3AD203B41FA5}">
                      <a16:colId xmlns:a16="http://schemas.microsoft.com/office/drawing/2014/main" val="1269273071"/>
                    </a:ext>
                  </a:extLst>
                </a:gridCol>
                <a:gridCol w="983916">
                  <a:extLst>
                    <a:ext uri="{9D8B030D-6E8A-4147-A177-3AD203B41FA5}">
                      <a16:colId xmlns:a16="http://schemas.microsoft.com/office/drawing/2014/main" val="89382091"/>
                    </a:ext>
                  </a:extLst>
                </a:gridCol>
                <a:gridCol w="805447">
                  <a:extLst>
                    <a:ext uri="{9D8B030D-6E8A-4147-A177-3AD203B41FA5}">
                      <a16:colId xmlns:a16="http://schemas.microsoft.com/office/drawing/2014/main" val="184516832"/>
                    </a:ext>
                  </a:extLst>
                </a:gridCol>
                <a:gridCol w="1484740">
                  <a:extLst>
                    <a:ext uri="{9D8B030D-6E8A-4147-A177-3AD203B41FA5}">
                      <a16:colId xmlns:a16="http://schemas.microsoft.com/office/drawing/2014/main" val="2216483607"/>
                    </a:ext>
                  </a:extLst>
                </a:gridCol>
              </a:tblGrid>
              <a:tr h="0"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rameter</a:t>
                      </a:r>
                      <a:r>
                        <a:rPr lang="pt-BR" sz="12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  </a:t>
                      </a:r>
                      <a:endParaRPr lang="pt-BR" sz="1200" b="1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D3D3"/>
                    </a:solidFill>
                  </a:tcPr>
                </a:tc>
                <a:tc rowSpan="2">
                  <a:txBody>
                    <a:bodyPr/>
                    <a:lstStyle/>
                    <a:p>
                      <a:pPr indent="75565"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 b="1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atment</a:t>
                      </a:r>
                      <a:endParaRPr lang="pt-BR" sz="1200" b="1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D3D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0</a:t>
                      </a:r>
                      <a:endParaRPr lang="pt-BR" sz="1200" b="1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D3D3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90</a:t>
                      </a:r>
                      <a:endParaRPr lang="pt-BR" sz="1200" b="1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D3D3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 b="1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ff</a:t>
                      </a:r>
                      <a:r>
                        <a:rPr lang="pt-BR" sz="12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pt-BR" sz="1200" b="1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tween</a:t>
                      </a:r>
                      <a:endParaRPr lang="pt-BR" sz="1200" b="1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 b="1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s</a:t>
                      </a:r>
                      <a:endParaRPr lang="pt-BR" sz="1200" b="1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D3D3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variation</a:t>
                      </a:r>
                      <a:endParaRPr lang="pt-BR" sz="1200" b="1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D3D3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</a:p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atment</a:t>
                      </a:r>
                      <a:endParaRPr lang="pt-BR" sz="1200" b="1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D3D3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</a:t>
                      </a:r>
                      <a:r>
                        <a:rPr lang="pt-BR" sz="1200" b="1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lue</a:t>
                      </a:r>
                      <a:endParaRPr lang="pt-BR" sz="1200" b="1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me</a:t>
                      </a:r>
                      <a:endParaRPr lang="pt-BR" sz="1200" b="1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D3D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98386305"/>
                  </a:ext>
                </a:extLst>
              </a:tr>
              <a:tr h="888978">
                <a:tc v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 b="1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</a:t>
                      </a:r>
                      <a:endParaRPr lang="pt-BR" sz="1200" b="1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D3D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D</a:t>
                      </a:r>
                      <a:endParaRPr lang="pt-BR" sz="1200" b="1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D3D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 b="1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</a:t>
                      </a:r>
                      <a:endParaRPr lang="pt-BR" sz="1200" b="1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D3D3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D</a:t>
                      </a:r>
                      <a:endParaRPr lang="pt-BR" sz="1200" b="1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D3D3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89769139"/>
                  </a:ext>
                </a:extLst>
              </a:tr>
              <a:tr h="533965">
                <a:tc rowSpan="2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pt-BR" sz="12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eyIdx</a:t>
                      </a:r>
                      <a:r>
                        <a:rPr lang="pt-BR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Grey Index)</a:t>
                      </a:r>
                      <a:endParaRPr lang="pt-BR" sz="12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HA</a:t>
                      </a:r>
                      <a:r>
                        <a:rPr lang="pt-BR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+ </a:t>
                      </a:r>
                      <a:r>
                        <a:rPr lang="pt-BR" sz="120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idocaine</a:t>
                      </a:r>
                      <a:endParaRPr lang="pt-BR" sz="120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.0</a:t>
                      </a:r>
                      <a:endParaRPr lang="pt-BR" sz="120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4</a:t>
                      </a:r>
                      <a:endParaRPr lang="pt-BR" sz="120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9.2</a:t>
                      </a:r>
                      <a:endParaRPr lang="pt-BR" sz="120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9</a:t>
                      </a:r>
                      <a:endParaRPr lang="pt-BR" sz="120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2</a:t>
                      </a:r>
                      <a:endParaRPr lang="pt-BR" sz="120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%</a:t>
                      </a:r>
                      <a:endParaRPr lang="pt-BR" sz="120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94</a:t>
                      </a:r>
                    </a:p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pt-BR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</a:p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pt-BR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83037085"/>
                  </a:ext>
                </a:extLst>
              </a:tr>
              <a:tr h="533965">
                <a:tc v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HA + Polymicronutrient</a:t>
                      </a:r>
                      <a:endParaRPr lang="pt-BR" sz="120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.6</a:t>
                      </a:r>
                      <a:endParaRPr lang="pt-BR" sz="120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8</a:t>
                      </a:r>
                      <a:endParaRPr lang="pt-BR" sz="120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2.5</a:t>
                      </a:r>
                      <a:endParaRPr lang="pt-BR" sz="120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9</a:t>
                      </a:r>
                      <a:endParaRPr lang="pt-BR" sz="120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9</a:t>
                      </a:r>
                      <a:endParaRPr lang="pt-BR" sz="120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%</a:t>
                      </a:r>
                      <a:endParaRPr lang="pt-BR" sz="120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0484512"/>
                  </a:ext>
                </a:extLst>
              </a:tr>
              <a:tr h="533965">
                <a:tc rowSpan="2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pt-BR" sz="12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GL</a:t>
                      </a:r>
                      <a:r>
                        <a:rPr lang="pt-BR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</a:t>
                      </a:r>
                      <a:r>
                        <a:rPr lang="pt-BR" sz="12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</a:t>
                      </a:r>
                      <a:r>
                        <a:rPr lang="pt-BR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Grey </a:t>
                      </a:r>
                      <a:r>
                        <a:rPr lang="pt-BR" sz="12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vel</a:t>
                      </a:r>
                      <a:r>
                        <a:rPr lang="pt-BR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pt-BR" sz="12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HA + Lidocaine</a:t>
                      </a:r>
                      <a:endParaRPr lang="pt-BR" sz="120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3</a:t>
                      </a:r>
                      <a:endParaRPr lang="pt-BR" sz="120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lang="pt-BR" sz="120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5</a:t>
                      </a:r>
                      <a:endParaRPr lang="pt-BR" sz="120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</a:t>
                      </a:r>
                      <a:endParaRPr lang="pt-BR" sz="120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8</a:t>
                      </a:r>
                      <a:endParaRPr lang="pt-BR" sz="120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8%</a:t>
                      </a:r>
                      <a:endParaRPr lang="pt-BR" sz="120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94</a:t>
                      </a:r>
                    </a:p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pt-BR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</a:p>
                    <a:p>
                      <a:pPr>
                        <a:lnSpc>
                          <a:spcPct val="115000"/>
                        </a:lnSpc>
                        <a:buNone/>
                      </a:pPr>
                      <a:r>
                        <a:rPr lang="pt-BR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66433220"/>
                  </a:ext>
                </a:extLst>
              </a:tr>
              <a:tr h="715416">
                <a:tc v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HA + Polymicronutrient</a:t>
                      </a:r>
                      <a:endParaRPr lang="pt-BR" sz="120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2</a:t>
                      </a:r>
                      <a:endParaRPr lang="pt-BR" sz="120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lang="pt-BR" sz="120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0</a:t>
                      </a:r>
                      <a:endParaRPr lang="pt-BR" sz="120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</a:t>
                      </a:r>
                      <a:endParaRPr lang="pt-BR" sz="120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2</a:t>
                      </a:r>
                      <a:endParaRPr lang="pt-BR" sz="120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buNone/>
                      </a:pPr>
                      <a:r>
                        <a:rPr lang="pt-BR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0%</a:t>
                      </a:r>
                      <a:endParaRPr lang="pt-BR" sz="1200" dirty="0">
                        <a:effectLst/>
                        <a:latin typeface="Times New Roman" panose="02020603050405020304" pitchFamily="18" charset="0"/>
                        <a:ea typeface="Arial" panose="020B06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44450" marR="4445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029581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576996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AEFB81AD9CEBFD42B4201155493304CC" ma:contentTypeVersion="14" ma:contentTypeDescription="Crie um novo documento." ma:contentTypeScope="" ma:versionID="1fb44819077120ec8b4d2093afd804e4">
  <xsd:schema xmlns:xsd="http://www.w3.org/2001/XMLSchema" xmlns:xs="http://www.w3.org/2001/XMLSchema" xmlns:p="http://schemas.microsoft.com/office/2006/metadata/properties" xmlns:ns2="2eb2843a-4398-4057-9470-809afaa94b37" xmlns:ns3="5ee299ba-814f-48ff-80ea-3d10db68c2ae" targetNamespace="http://schemas.microsoft.com/office/2006/metadata/properties" ma:root="true" ma:fieldsID="ee7ed6cfd9eef3f3324dc1f6f21e4a7e" ns2:_="" ns3:_="">
    <xsd:import namespace="2eb2843a-4398-4057-9470-809afaa94b37"/>
    <xsd:import namespace="5ee299ba-814f-48ff-80ea-3d10db68c2ae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ObjectDetectorVersions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LengthInSeconds" minOccurs="0"/>
                <xsd:element ref="ns2:MediaServiceLocation" minOccurs="0"/>
                <xsd:element ref="ns2:MediaServiceSearchProperties" minOccurs="0"/>
                <xsd:element ref="ns2:MediaServiceBilling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eb2843a-4398-4057-9470-809afaa94b3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lcf76f155ced4ddcb4097134ff3c332f" ma:index="12" nillable="true" ma:taxonomy="true" ma:internalName="lcf76f155ced4ddcb4097134ff3c332f" ma:taxonomyFieldName="MediaServiceImageTags" ma:displayName="Marcações de imagem" ma:readOnly="false" ma:fieldId="{5cf76f15-5ced-4ddc-b409-7134ff3c332f}" ma:taxonomyMulti="true" ma:sspId="fea7dbe5-a9f3-44e3-967d-25ae73bd90b2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7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LengthInSeconds" ma:index="18" nillable="true" ma:displayName="MediaLengthInSeconds" ma:hidden="true" ma:internalName="MediaLengthInSeconds" ma:readOnly="true">
      <xsd:simpleType>
        <xsd:restriction base="dms:Unknown"/>
      </xsd:simpleType>
    </xsd:element>
    <xsd:element name="MediaServiceLocation" ma:index="19" nillable="true" ma:displayName="Location" ma:indexed="true" ma:internalName="MediaServiceLocation" ma:readOnly="true">
      <xsd:simpleType>
        <xsd:restriction base="dms:Text"/>
      </xsd:simpleType>
    </xsd:element>
    <xsd:element name="MediaServiceSearchProperties" ma:index="2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BillingMetadata" ma:index="21" nillable="true" ma:displayName="MediaServiceBillingMetadata" ma:hidden="true" ma:internalName="MediaServiceBillingMetadata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ee299ba-814f-48ff-80ea-3d10db68c2ae" elementFormDefault="qualified">
    <xsd:import namespace="http://schemas.microsoft.com/office/2006/documentManagement/types"/>
    <xsd:import namespace="http://schemas.microsoft.com/office/infopath/2007/PartnerControls"/>
    <xsd:element name="TaxCatchAll" ma:index="13" nillable="true" ma:displayName="Taxonomy Catch All Column" ma:hidden="true" ma:list="{3240f1ee-3a42-421c-8b4a-914b4e7e2b10}" ma:internalName="TaxCatchAll" ma:showField="CatchAllData" ma:web="5ee299ba-814f-48ff-80ea-3d10db68c2ae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e Conteúdo"/>
        <xsd:element ref="dc:title" minOccurs="0" maxOccurs="1" ma:index="4" ma:displayName="Títu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5ee299ba-814f-48ff-80ea-3d10db68c2ae" xsi:nil="true"/>
    <lcf76f155ced4ddcb4097134ff3c332f xmlns="2eb2843a-4398-4057-9470-809afaa94b37">
      <Terms xmlns="http://schemas.microsoft.com/office/infopath/2007/PartnerControls"/>
    </lcf76f155ced4ddcb4097134ff3c332f>
  </documentManagement>
</p:properties>
</file>

<file path=customXml/itemProps1.xml><?xml version="1.0" encoding="utf-8"?>
<ds:datastoreItem xmlns:ds="http://schemas.openxmlformats.org/officeDocument/2006/customXml" ds:itemID="{8CC7EA4C-BDAF-42F8-BC21-51C0FCA0749B}"/>
</file>

<file path=customXml/itemProps2.xml><?xml version="1.0" encoding="utf-8"?>
<ds:datastoreItem xmlns:ds="http://schemas.openxmlformats.org/officeDocument/2006/customXml" ds:itemID="{D60582F6-860C-445E-96DF-94EF9FED50E2}"/>
</file>

<file path=customXml/itemProps3.xml><?xml version="1.0" encoding="utf-8"?>
<ds:datastoreItem xmlns:ds="http://schemas.openxmlformats.org/officeDocument/2006/customXml" ds:itemID="{ED19FA40-06ED-4AB3-9966-8B8430368181}"/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82</Words>
  <Application>Microsoft Office PowerPoint</Application>
  <PresentationFormat>Widescreen</PresentationFormat>
  <Paragraphs>53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eatriz Domenici de Oliveira</dc:creator>
  <cp:lastModifiedBy>Beatriz Domenici de Oliveira</cp:lastModifiedBy>
  <cp:revision>1</cp:revision>
  <dcterms:created xsi:type="dcterms:W3CDTF">2026-02-05T13:17:58Z</dcterms:created>
  <dcterms:modified xsi:type="dcterms:W3CDTF">2026-02-05T13:37:5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EFB81AD9CEBFD42B4201155493304CC</vt:lpwstr>
  </property>
</Properties>
</file>